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301" r:id="rId2"/>
  </p:sldIdLst>
  <p:sldSz cx="6858000" cy="2743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FF"/>
    <a:srgbClr val="009AD0"/>
    <a:srgbClr val="8156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701" autoAdjust="0"/>
    <p:restoredTop sz="94660"/>
  </p:normalViewPr>
  <p:slideViewPr>
    <p:cSldViewPr snapToGrid="0">
      <p:cViewPr varScale="1">
        <p:scale>
          <a:sx n="158" d="100"/>
          <a:sy n="158" d="100"/>
        </p:scale>
        <p:origin x="461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Macintosh%20HD:Users:luis:Desktop:elisa%20nanodiscs:Nanodisc%20Env%20ELIS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uis:Desktop:elisa%20nanodiscs:Nanodisc%20Env%20ELIS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268893599153703"/>
          <c:y val="0.26658660592005667"/>
          <c:w val="0.48983653863318327"/>
          <c:h val="0.509341160204665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A$26</c:f>
              <c:strCache>
                <c:ptCount val="1"/>
                <c:pt idx="0">
                  <c:v>anti LAM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Hoja1!$Q$26:$S$26</c:f>
                <c:numCache>
                  <c:formatCode>General</c:formatCode>
                  <c:ptCount val="3"/>
                  <c:pt idx="0">
                    <c:v>157695.3157037858</c:v>
                  </c:pt>
                  <c:pt idx="1">
                    <c:v>84691.175787681699</c:v>
                  </c:pt>
                  <c:pt idx="2">
                    <c:v>2106.4938483967462</c:v>
                  </c:pt>
                </c:numCache>
              </c:numRef>
            </c:plus>
            <c:minus>
              <c:numRef>
                <c:f>Hoja1!$Q$26:$S$26</c:f>
                <c:numCache>
                  <c:formatCode>General</c:formatCode>
                  <c:ptCount val="3"/>
                  <c:pt idx="0">
                    <c:v>157695.3157037858</c:v>
                  </c:pt>
                  <c:pt idx="1">
                    <c:v>84691.175787681699</c:v>
                  </c:pt>
                  <c:pt idx="2">
                    <c:v>2106.4938483967462</c:v>
                  </c:pt>
                </c:numCache>
              </c:numRef>
            </c:minus>
          </c:errBars>
          <c:cat>
            <c:strRef>
              <c:f>Hoja1!$N$25:$P$25</c:f>
              <c:strCache>
                <c:ptCount val="3"/>
                <c:pt idx="0">
                  <c:v>Glutaraldehyde</c:v>
                </c:pt>
                <c:pt idx="1">
                  <c:v>No Glutaraldehyde</c:v>
                </c:pt>
                <c:pt idx="2">
                  <c:v>Nanodisc control</c:v>
                </c:pt>
              </c:strCache>
            </c:strRef>
          </c:cat>
          <c:val>
            <c:numRef>
              <c:f>Hoja1!$N$26:$P$26</c:f>
              <c:numCache>
                <c:formatCode>General</c:formatCode>
                <c:ptCount val="3"/>
                <c:pt idx="0">
                  <c:v>2613438.75</c:v>
                </c:pt>
                <c:pt idx="1">
                  <c:v>2404917.6</c:v>
                </c:pt>
                <c:pt idx="2">
                  <c:v>1464.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0A-4EAA-9156-B1EC0F5AFE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8906880"/>
        <c:axId val="578907272"/>
      </c:barChart>
      <c:catAx>
        <c:axId val="578906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solidFill>
            <a:schemeClr val="bg1"/>
          </a:solidFill>
        </c:spPr>
        <c:crossAx val="578907272"/>
        <c:crossesAt val="0"/>
        <c:auto val="1"/>
        <c:lblAlgn val="ctr"/>
        <c:lblOffset val="100"/>
        <c:noMultiLvlLbl val="0"/>
      </c:catAx>
      <c:valAx>
        <c:axId val="578907272"/>
        <c:scaling>
          <c:orientation val="minMax"/>
          <c:max val="30000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578906880"/>
        <c:crosses val="autoZero"/>
        <c:crossBetween val="between"/>
        <c:majorUnit val="500000"/>
        <c:minorUnit val="100000"/>
        <c:dispUnits>
          <c:builtInUnit val="hundredThousands"/>
        </c:dispUnits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817243616338309"/>
          <c:y val="0.22319101453370604"/>
          <c:w val="0.87182756383661697"/>
          <c:h val="0.532158137087841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A$27</c:f>
              <c:strCache>
                <c:ptCount val="1"/>
                <c:pt idx="0">
                  <c:v>anti LP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Hoja1!$Q$27:$S$27</c:f>
                <c:numCache>
                  <c:formatCode>General</c:formatCode>
                  <c:ptCount val="3"/>
                  <c:pt idx="0">
                    <c:v>46323.224567524812</c:v>
                  </c:pt>
                  <c:pt idx="1">
                    <c:v>62230.233040969018</c:v>
                  </c:pt>
                  <c:pt idx="2">
                    <c:v>388.55673116461821</c:v>
                  </c:pt>
                </c:numCache>
              </c:numRef>
            </c:plus>
            <c:minus>
              <c:numRef>
                <c:f>Hoja1!$Q$27:$S$27</c:f>
                <c:numCache>
                  <c:formatCode>General</c:formatCode>
                  <c:ptCount val="3"/>
                  <c:pt idx="0">
                    <c:v>46323.224567524812</c:v>
                  </c:pt>
                  <c:pt idx="1">
                    <c:v>62230.233040969018</c:v>
                  </c:pt>
                  <c:pt idx="2">
                    <c:v>388.55673116461821</c:v>
                  </c:pt>
                </c:numCache>
              </c:numRef>
            </c:minus>
          </c:errBars>
          <c:cat>
            <c:strRef>
              <c:f>Hoja1!$N$25:$P$25</c:f>
              <c:strCache>
                <c:ptCount val="3"/>
                <c:pt idx="0">
                  <c:v>Glutaraldehyde</c:v>
                </c:pt>
                <c:pt idx="1">
                  <c:v>No Glutaraldehyde</c:v>
                </c:pt>
                <c:pt idx="2">
                  <c:v>Nanodisc control</c:v>
                </c:pt>
              </c:strCache>
            </c:strRef>
          </c:cat>
          <c:val>
            <c:numRef>
              <c:f>Hoja1!$N$27:$P$27</c:f>
              <c:numCache>
                <c:formatCode>General</c:formatCode>
                <c:ptCount val="3"/>
                <c:pt idx="0">
                  <c:v>702406.33333333337</c:v>
                </c:pt>
                <c:pt idx="1">
                  <c:v>676835.66666666698</c:v>
                </c:pt>
                <c:pt idx="2">
                  <c:v>391.33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46-4838-970F-7220718A4D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8917464"/>
        <c:axId val="578918248"/>
      </c:barChart>
      <c:catAx>
        <c:axId val="5789174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578918248"/>
        <c:crosses val="autoZero"/>
        <c:auto val="1"/>
        <c:lblAlgn val="ctr"/>
        <c:lblOffset val="100"/>
        <c:noMultiLvlLbl val="0"/>
      </c:catAx>
      <c:valAx>
        <c:axId val="578918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578917464"/>
        <c:crosses val="autoZero"/>
        <c:crossBetween val="between"/>
        <c:dispUnits>
          <c:builtInUnit val="tenThousands"/>
        </c:dispUnits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789</cdr:x>
      <cdr:y>0.84331</cdr:y>
    </cdr:from>
    <cdr:to>
      <cdr:x>0.36363</cdr:x>
      <cdr:y>0.9180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009887" y="1031608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DD9BC3-A87F-4B2E-841D-BB48842DD1C1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428625" y="1143000"/>
            <a:ext cx="77152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DA84F7-CE3F-4B2D-81E5-3229BA54D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995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1pPr>
    <a:lvl2pPr marL="190470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2pPr>
    <a:lvl3pPr marL="380939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3pPr>
    <a:lvl4pPr marL="571409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4pPr>
    <a:lvl5pPr marL="761878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5pPr>
    <a:lvl6pPr marL="952348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6pPr>
    <a:lvl7pPr marL="1142817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7pPr>
    <a:lvl8pPr marL="1333287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8pPr>
    <a:lvl9pPr marL="1523756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448945"/>
            <a:ext cx="5143500" cy="955040"/>
          </a:xfrm>
        </p:spPr>
        <p:txBody>
          <a:bodyPr anchor="b"/>
          <a:lstStyle>
            <a:lvl1pPr algn="ctr"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1440815"/>
            <a:ext cx="5143500" cy="662305"/>
          </a:xfrm>
        </p:spPr>
        <p:txBody>
          <a:bodyPr/>
          <a:lstStyle>
            <a:lvl1pPr marL="0" indent="0" algn="ctr">
              <a:buNone/>
              <a:defRPr sz="960"/>
            </a:lvl1pPr>
            <a:lvl2pPr marL="182880" indent="0" algn="ctr">
              <a:buNone/>
              <a:defRPr sz="800"/>
            </a:lvl2pPr>
            <a:lvl3pPr marL="365760" indent="0" algn="ctr">
              <a:buNone/>
              <a:defRPr sz="720"/>
            </a:lvl3pPr>
            <a:lvl4pPr marL="548640" indent="0" algn="ctr">
              <a:buNone/>
              <a:defRPr sz="640"/>
            </a:lvl4pPr>
            <a:lvl5pPr marL="731520" indent="0" algn="ctr">
              <a:buNone/>
              <a:defRPr sz="640"/>
            </a:lvl5pPr>
            <a:lvl6pPr marL="914400" indent="0" algn="ctr">
              <a:buNone/>
              <a:defRPr sz="640"/>
            </a:lvl6pPr>
            <a:lvl7pPr marL="1097280" indent="0" algn="ctr">
              <a:buNone/>
              <a:defRPr sz="640"/>
            </a:lvl7pPr>
            <a:lvl8pPr marL="1280160" indent="0" algn="ctr">
              <a:buNone/>
              <a:defRPr sz="640"/>
            </a:lvl8pPr>
            <a:lvl9pPr marL="1463040" indent="0" algn="ctr">
              <a:buNone/>
              <a:defRPr sz="6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177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671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146050"/>
            <a:ext cx="1478756" cy="232473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146050"/>
            <a:ext cx="4350544" cy="232473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709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89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683895"/>
            <a:ext cx="5915025" cy="114109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1835785"/>
            <a:ext cx="5915025" cy="600075"/>
          </a:xfrm>
        </p:spPr>
        <p:txBody>
          <a:bodyPr/>
          <a:lstStyle>
            <a:lvl1pPr marL="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1pPr>
            <a:lvl2pPr marL="18288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2pPr>
            <a:lvl3pPr marL="365760" indent="0">
              <a:buNone/>
              <a:defRPr sz="720">
                <a:solidFill>
                  <a:schemeClr val="tx1">
                    <a:tint val="75000"/>
                  </a:schemeClr>
                </a:solidFill>
              </a:defRPr>
            </a:lvl3pPr>
            <a:lvl4pPr marL="54864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4pPr>
            <a:lvl5pPr marL="73152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5pPr>
            <a:lvl6pPr marL="91440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6pPr>
            <a:lvl7pPr marL="109728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7pPr>
            <a:lvl8pPr marL="128016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8pPr>
            <a:lvl9pPr marL="146304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671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730250"/>
            <a:ext cx="2914650" cy="174053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730250"/>
            <a:ext cx="2914650" cy="174053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020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46050"/>
            <a:ext cx="5915025" cy="5302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672465"/>
            <a:ext cx="2901255" cy="329565"/>
          </a:xfrm>
        </p:spPr>
        <p:txBody>
          <a:bodyPr anchor="b"/>
          <a:lstStyle>
            <a:lvl1pPr marL="0" indent="0">
              <a:buNone/>
              <a:defRPr sz="960" b="1"/>
            </a:lvl1pPr>
            <a:lvl2pPr marL="182880" indent="0">
              <a:buNone/>
              <a:defRPr sz="800" b="1"/>
            </a:lvl2pPr>
            <a:lvl3pPr marL="365760" indent="0">
              <a:buNone/>
              <a:defRPr sz="720" b="1"/>
            </a:lvl3pPr>
            <a:lvl4pPr marL="548640" indent="0">
              <a:buNone/>
              <a:defRPr sz="640" b="1"/>
            </a:lvl4pPr>
            <a:lvl5pPr marL="731520" indent="0">
              <a:buNone/>
              <a:defRPr sz="640" b="1"/>
            </a:lvl5pPr>
            <a:lvl6pPr marL="914400" indent="0">
              <a:buNone/>
              <a:defRPr sz="640" b="1"/>
            </a:lvl6pPr>
            <a:lvl7pPr marL="1097280" indent="0">
              <a:buNone/>
              <a:defRPr sz="640" b="1"/>
            </a:lvl7pPr>
            <a:lvl8pPr marL="1280160" indent="0">
              <a:buNone/>
              <a:defRPr sz="640" b="1"/>
            </a:lvl8pPr>
            <a:lvl9pPr marL="1463040" indent="0">
              <a:buNone/>
              <a:defRPr sz="6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1002030"/>
            <a:ext cx="2901255" cy="147383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672465"/>
            <a:ext cx="2915543" cy="329565"/>
          </a:xfrm>
        </p:spPr>
        <p:txBody>
          <a:bodyPr anchor="b"/>
          <a:lstStyle>
            <a:lvl1pPr marL="0" indent="0">
              <a:buNone/>
              <a:defRPr sz="960" b="1"/>
            </a:lvl1pPr>
            <a:lvl2pPr marL="182880" indent="0">
              <a:buNone/>
              <a:defRPr sz="800" b="1"/>
            </a:lvl2pPr>
            <a:lvl3pPr marL="365760" indent="0">
              <a:buNone/>
              <a:defRPr sz="720" b="1"/>
            </a:lvl3pPr>
            <a:lvl4pPr marL="548640" indent="0">
              <a:buNone/>
              <a:defRPr sz="640" b="1"/>
            </a:lvl4pPr>
            <a:lvl5pPr marL="731520" indent="0">
              <a:buNone/>
              <a:defRPr sz="640" b="1"/>
            </a:lvl5pPr>
            <a:lvl6pPr marL="914400" indent="0">
              <a:buNone/>
              <a:defRPr sz="640" b="1"/>
            </a:lvl6pPr>
            <a:lvl7pPr marL="1097280" indent="0">
              <a:buNone/>
              <a:defRPr sz="640" b="1"/>
            </a:lvl7pPr>
            <a:lvl8pPr marL="1280160" indent="0">
              <a:buNone/>
              <a:defRPr sz="640" b="1"/>
            </a:lvl8pPr>
            <a:lvl9pPr marL="1463040" indent="0">
              <a:buNone/>
              <a:defRPr sz="6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1002030"/>
            <a:ext cx="2915543" cy="147383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19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456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558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82880"/>
            <a:ext cx="2211883" cy="640080"/>
          </a:xfrm>
        </p:spPr>
        <p:txBody>
          <a:bodyPr anchor="b"/>
          <a:lstStyle>
            <a:lvl1pPr>
              <a:defRPr sz="12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394970"/>
            <a:ext cx="3471863" cy="1949450"/>
          </a:xfrm>
        </p:spPr>
        <p:txBody>
          <a:bodyPr/>
          <a:lstStyle>
            <a:lvl1pPr>
              <a:defRPr sz="1280"/>
            </a:lvl1pPr>
            <a:lvl2pPr>
              <a:defRPr sz="1120"/>
            </a:lvl2pPr>
            <a:lvl3pPr>
              <a:defRPr sz="96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822960"/>
            <a:ext cx="2211883" cy="1524635"/>
          </a:xfrm>
        </p:spPr>
        <p:txBody>
          <a:bodyPr/>
          <a:lstStyle>
            <a:lvl1pPr marL="0" indent="0">
              <a:buNone/>
              <a:defRPr sz="640"/>
            </a:lvl1pPr>
            <a:lvl2pPr marL="182880" indent="0">
              <a:buNone/>
              <a:defRPr sz="560"/>
            </a:lvl2pPr>
            <a:lvl3pPr marL="365760" indent="0">
              <a:buNone/>
              <a:defRPr sz="480"/>
            </a:lvl3pPr>
            <a:lvl4pPr marL="548640" indent="0">
              <a:buNone/>
              <a:defRPr sz="400"/>
            </a:lvl4pPr>
            <a:lvl5pPr marL="731520" indent="0">
              <a:buNone/>
              <a:defRPr sz="400"/>
            </a:lvl5pPr>
            <a:lvl6pPr marL="914400" indent="0">
              <a:buNone/>
              <a:defRPr sz="400"/>
            </a:lvl6pPr>
            <a:lvl7pPr marL="1097280" indent="0">
              <a:buNone/>
              <a:defRPr sz="400"/>
            </a:lvl7pPr>
            <a:lvl8pPr marL="1280160" indent="0">
              <a:buNone/>
              <a:defRPr sz="400"/>
            </a:lvl8pPr>
            <a:lvl9pPr marL="1463040" indent="0">
              <a:buNone/>
              <a:defRPr sz="4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222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82880"/>
            <a:ext cx="2211883" cy="640080"/>
          </a:xfrm>
        </p:spPr>
        <p:txBody>
          <a:bodyPr anchor="b"/>
          <a:lstStyle>
            <a:lvl1pPr>
              <a:defRPr sz="12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394970"/>
            <a:ext cx="3471863" cy="1949450"/>
          </a:xfrm>
        </p:spPr>
        <p:txBody>
          <a:bodyPr anchor="t"/>
          <a:lstStyle>
            <a:lvl1pPr marL="0" indent="0">
              <a:buNone/>
              <a:defRPr sz="1280"/>
            </a:lvl1pPr>
            <a:lvl2pPr marL="182880" indent="0">
              <a:buNone/>
              <a:defRPr sz="1120"/>
            </a:lvl2pPr>
            <a:lvl3pPr marL="365760" indent="0">
              <a:buNone/>
              <a:defRPr sz="960"/>
            </a:lvl3pPr>
            <a:lvl4pPr marL="548640" indent="0">
              <a:buNone/>
              <a:defRPr sz="800"/>
            </a:lvl4pPr>
            <a:lvl5pPr marL="731520" indent="0">
              <a:buNone/>
              <a:defRPr sz="800"/>
            </a:lvl5pPr>
            <a:lvl6pPr marL="914400" indent="0">
              <a:buNone/>
              <a:defRPr sz="800"/>
            </a:lvl6pPr>
            <a:lvl7pPr marL="1097280" indent="0">
              <a:buNone/>
              <a:defRPr sz="800"/>
            </a:lvl7pPr>
            <a:lvl8pPr marL="1280160" indent="0">
              <a:buNone/>
              <a:defRPr sz="800"/>
            </a:lvl8pPr>
            <a:lvl9pPr marL="1463040" indent="0">
              <a:buNone/>
              <a:defRPr sz="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822960"/>
            <a:ext cx="2211883" cy="1524635"/>
          </a:xfrm>
        </p:spPr>
        <p:txBody>
          <a:bodyPr/>
          <a:lstStyle>
            <a:lvl1pPr marL="0" indent="0">
              <a:buNone/>
              <a:defRPr sz="640"/>
            </a:lvl1pPr>
            <a:lvl2pPr marL="182880" indent="0">
              <a:buNone/>
              <a:defRPr sz="560"/>
            </a:lvl2pPr>
            <a:lvl3pPr marL="365760" indent="0">
              <a:buNone/>
              <a:defRPr sz="480"/>
            </a:lvl3pPr>
            <a:lvl4pPr marL="548640" indent="0">
              <a:buNone/>
              <a:defRPr sz="400"/>
            </a:lvl4pPr>
            <a:lvl5pPr marL="731520" indent="0">
              <a:buNone/>
              <a:defRPr sz="400"/>
            </a:lvl5pPr>
            <a:lvl6pPr marL="914400" indent="0">
              <a:buNone/>
              <a:defRPr sz="400"/>
            </a:lvl6pPr>
            <a:lvl7pPr marL="1097280" indent="0">
              <a:buNone/>
              <a:defRPr sz="400"/>
            </a:lvl7pPr>
            <a:lvl8pPr marL="1280160" indent="0">
              <a:buNone/>
              <a:defRPr sz="400"/>
            </a:lvl8pPr>
            <a:lvl9pPr marL="1463040" indent="0">
              <a:buNone/>
              <a:defRPr sz="4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187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146050"/>
            <a:ext cx="5915025" cy="53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730250"/>
            <a:ext cx="5915025" cy="17405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2542540"/>
            <a:ext cx="1543050" cy="146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26B4C-DE86-4CEF-B3B0-7D4D61DA3787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2542540"/>
            <a:ext cx="2314575" cy="146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2542540"/>
            <a:ext cx="1543050" cy="146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654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65760" rtl="0" eaLnBrk="1" latinLnBrk="0" hangingPunct="1">
        <a:lnSpc>
          <a:spcPct val="90000"/>
        </a:lnSpc>
        <a:spcBef>
          <a:spcPct val="0"/>
        </a:spcBef>
        <a:buNone/>
        <a:defRPr sz="17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36576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12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3116" y="294237"/>
            <a:ext cx="5776957" cy="271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-751219" y="325781"/>
            <a:ext cx="7044942" cy="2046789"/>
            <a:chOff x="-2281092" y="14426137"/>
            <a:chExt cx="19094717" cy="4366968"/>
          </a:xfrm>
        </p:grpSpPr>
        <p:graphicFrame>
          <p:nvGraphicFramePr>
            <p:cNvPr id="11" name="Gráfico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64364474"/>
                </p:ext>
              </p:extLst>
            </p:nvPr>
          </p:nvGraphicFramePr>
          <p:xfrm>
            <a:off x="-859735" y="14634267"/>
            <a:ext cx="11997217" cy="41171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2" name="Gráfico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90602797"/>
                </p:ext>
              </p:extLst>
            </p:nvPr>
          </p:nvGraphicFramePr>
          <p:xfrm>
            <a:off x="9968187" y="14854797"/>
            <a:ext cx="6845438" cy="393830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3" name="CuadroTexto 6"/>
            <p:cNvSpPr txBox="1"/>
            <p:nvPr/>
          </p:nvSpPr>
          <p:spPr>
            <a:xfrm>
              <a:off x="2970665" y="15179923"/>
              <a:ext cx="2076300" cy="5121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60" dirty="0">
                  <a:latin typeface="Arial"/>
                  <a:cs typeface="Arial"/>
                </a:rPr>
                <a:t>α</a:t>
              </a:r>
              <a:r>
                <a:rPr lang="es-ES" sz="960" i="1" dirty="0">
                  <a:latin typeface="Arial"/>
                  <a:cs typeface="Arial"/>
                </a:rPr>
                <a:t> </a:t>
              </a:r>
              <a:r>
                <a:rPr lang="es-ES" sz="960" dirty="0">
                  <a:latin typeface="Arial"/>
                  <a:cs typeface="Arial"/>
                </a:rPr>
                <a:t>LAM-MS</a:t>
              </a:r>
              <a:endParaRPr lang="es-ES" sz="960" i="1" dirty="0">
                <a:latin typeface="Arial"/>
                <a:cs typeface="Arial"/>
              </a:endParaRPr>
            </a:p>
          </p:txBody>
        </p:sp>
        <p:sp>
          <p:nvSpPr>
            <p:cNvPr id="14" name="CuadroTexto 7"/>
            <p:cNvSpPr txBox="1"/>
            <p:nvPr/>
          </p:nvSpPr>
          <p:spPr>
            <a:xfrm>
              <a:off x="12137569" y="15183266"/>
              <a:ext cx="1558570" cy="5121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60" dirty="0">
                  <a:latin typeface="Arial"/>
                  <a:cs typeface="Arial"/>
                </a:rPr>
                <a:t>α LPS</a:t>
              </a:r>
              <a:endParaRPr lang="es-ES" sz="960" i="1" dirty="0"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29384" y="14495608"/>
              <a:ext cx="6731048" cy="512198"/>
            </a:xfrm>
            <a:prstGeom prst="rect">
              <a:avLst/>
            </a:prstGeom>
            <a:noFill/>
            <a:scene3d>
              <a:camera prst="orthographicFront">
                <a:rot lat="0" lon="0" rev="540000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n-US" sz="960" dirty="0">
                  <a:latin typeface="Arial"/>
                  <a:cs typeface="Arial"/>
                </a:rPr>
                <a:t>RLU x 10000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-2281092" y="14426137"/>
              <a:ext cx="6731048" cy="512198"/>
            </a:xfrm>
            <a:prstGeom prst="rect">
              <a:avLst/>
            </a:prstGeom>
            <a:noFill/>
            <a:scene3d>
              <a:camera prst="orthographicFront">
                <a:rot lat="0" lon="0" rev="540000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n-US" sz="960" dirty="0">
                  <a:latin typeface="Arial"/>
                  <a:cs typeface="Arial"/>
                </a:rPr>
                <a:t>RLU x 1000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59916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066</TotalTime>
  <Words>14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ten Witt</dc:creator>
  <cp:lastModifiedBy>kristenwitt@outlook.com</cp:lastModifiedBy>
  <cp:revision>445</cp:revision>
  <dcterms:created xsi:type="dcterms:W3CDTF">2016-04-05T18:18:37Z</dcterms:created>
  <dcterms:modified xsi:type="dcterms:W3CDTF">2016-09-14T02:20:37Z</dcterms:modified>
</cp:coreProperties>
</file>